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69" r:id="rId1"/>
  </p:sldMasterIdLst>
  <p:notesMasterIdLst>
    <p:notesMasterId r:id="rId3"/>
  </p:notesMasterIdLst>
  <p:sldIdLst>
    <p:sldId id="29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FF"/>
    <a:srgbClr val="AC04A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613" autoAdjust="0"/>
    <p:restoredTop sz="96357" autoAdjust="0"/>
  </p:normalViewPr>
  <p:slideViewPr>
    <p:cSldViewPr snapToGrid="0">
      <p:cViewPr varScale="1">
        <p:scale>
          <a:sx n="110" d="100"/>
          <a:sy n="110" d="100"/>
        </p:scale>
        <p:origin x="858" y="138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-8946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7FADA1F-E3BC-4FBA-88AF-198F841D33CB}" type="datetimeFigureOut">
              <a:rPr lang="en-US" smtClean="0"/>
              <a:t>5/22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5595147-72AB-4248-BBAB-5E4406E5A5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8741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5595147-72AB-4248-BBAB-5E4406E5A5B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54238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0E5706-8F14-BFF7-BE0C-6C685AF95E0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0F75C84-AB01-C63D-310C-7A4C4774533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4E88A3-4FB5-7517-4EE3-EAD7EF35DE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84A43C-5F78-42C3-A9D9-8D8C84DBC6BB}" type="datetime1">
              <a:rPr lang="en-US" smtClean="0"/>
              <a:t>5/22/2023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46EBE3-5EA8-B3E2-A45D-1BF19BA9B5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B26EC5-4BD5-FE8E-0FCB-5B79BC8CE5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87617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883EAD-DB85-238C-0648-0797A50886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433EE38-97F6-5711-BBCE-E562DE06CD1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BC0E65-82C3-74B9-86EA-ABEC0FD222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89718-1F9A-4C1F-93AE-5036A61C958C}" type="datetime1">
              <a:rPr lang="en-US" smtClean="0"/>
              <a:t>5/22/2023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8015AB-C3B6-9A94-575E-F8D2660168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FBBD9F-BF8F-AFE9-605E-BB40F9475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76218854"/>
      </p:ext>
    </p:extLst>
  </p:cSld>
  <p:clrMapOvr>
    <a:masterClrMapping/>
  </p:clrMapOvr>
  <p:hf hdr="0" ftr="0" dt="0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5201E65-85D4-C295-2F38-8FCE97502FE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70934BB-DE2E-53A6-7A36-BCE97D225C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1FA3F4-EC8D-713A-4747-85726C2257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89718-1F9A-4C1F-93AE-5036A61C958C}" type="datetime1">
              <a:rPr lang="en-US" smtClean="0"/>
              <a:t>5/22/2023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7B10DD-E53A-15FC-AC84-01B43E78C9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45B504-7875-D405-F3B9-60EDEAA387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70658597"/>
      </p:ext>
    </p:extLst>
  </p:cSld>
  <p:clrMapOvr>
    <a:masterClrMapping/>
  </p:clrMapOvr>
  <p:hf hdr="0" ftr="0" dt="0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1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2" name="Content Placeholder 2"/>
          <p:cNvSpPr>
            <a:spLocks noGrp="1"/>
          </p:cNvSpPr>
          <p:nvPr>
            <p:ph sz="quarter" idx="13"/>
          </p:nvPr>
        </p:nvSpPr>
        <p:spPr>
          <a:xfrm>
            <a:off x="913774" y="2367092"/>
            <a:ext cx="10363826" cy="342410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CDD2C-E9B4-482E-8541-515E1D30D294}" type="datetime1">
              <a:rPr lang="en-US" smtClean="0"/>
              <a:t>5/22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880835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01FE7C-B116-1993-146A-9F518C64C3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499EC1-F8F8-430E-3FB8-6CCFA09CE1F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98153D-68BD-2B5F-EFD6-981A82684E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89718-1F9A-4C1F-93AE-5036A61C958C}" type="datetime1">
              <a:rPr lang="en-US" smtClean="0"/>
              <a:t>5/22/2023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C12E98-72D7-B98B-DD3D-4C777C8A8C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400ED5-FD74-E385-D453-B74FB9B6C2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0164925"/>
      </p:ext>
    </p:extLst>
  </p:cSld>
  <p:clrMapOvr>
    <a:masterClrMapping/>
  </p:clrMapOvr>
  <p:hf hdr="0" ft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4767CF-7870-05A9-C8D0-BBAE16D3F2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4B64D4-F870-DE0E-DBC7-5446F48AAD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66C50B-ADC9-2DA2-2905-F43E07AC5C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B666A-4E7A-48EA-8A44-3F8E3611875F}" type="datetime1">
              <a:rPr lang="en-US" smtClean="0"/>
              <a:t>5/22/2023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3EC1EB-49DB-60F0-26DF-E3C1E3DD27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FD3CEE-90E8-3954-2A71-951081647F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268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D3A8F6-A43A-FC6F-8CAE-2C9DBA6249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6886DA-5E11-A17A-D768-6D29482A26B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7084830-D9CC-C782-4D43-1BA91D6E22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DA9B30-B4C4-19E2-2E26-A43D1C9EBE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89718-1F9A-4C1F-93AE-5036A61C958C}" type="datetime1">
              <a:rPr lang="en-US" smtClean="0"/>
              <a:t>5/22/2023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F8871FC-EB19-B737-871F-4FADD561AC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5231752-CDD2-F84F-FBBF-611ABADE5E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33211366"/>
      </p:ext>
    </p:extLst>
  </p:cSld>
  <p:clrMapOvr>
    <a:masterClrMapping/>
  </p:clrMapOvr>
  <p:hf hdr="0" ftr="0" dt="0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4FCAF4-E76E-11BA-9CF1-7313A4836A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B2300A7-B9A9-E2BC-2FB8-6C0CD09954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257BF2F-8378-5F96-EFB3-80182541BD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3EC1D2D-768D-0AC7-4AC2-F4F6D8AAD81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BEE7795-BBF3-8A56-EB1A-FAA515EA0FD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8B400FA-D5F2-9E93-18DC-A5930F295C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89718-1F9A-4C1F-93AE-5036A61C958C}" type="datetime1">
              <a:rPr lang="en-US" smtClean="0"/>
              <a:t>5/22/2023</a:t>
            </a:fld>
            <a:endParaRPr lang="en-US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A3DCECB-0C29-9747-0702-E25F2C56F4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A37A3DB-37D4-53EB-9591-BBFFD2E307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1845684"/>
      </p:ext>
    </p:extLst>
  </p:cSld>
  <p:clrMapOvr>
    <a:masterClrMapping/>
  </p:clrMapOvr>
  <p:hf hdr="0" ftr="0" dt="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AFF36D-8180-6EF4-BCA6-F207085FDD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868E860-C849-9481-59C4-C26C5FBAB9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AAFE7-52D9-4E4C-BA8B-C574D5A0971B}" type="datetime1">
              <a:rPr lang="en-US" smtClean="0"/>
              <a:t>5/22/2023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A0E26E8-5B17-C12E-5706-7186292FEA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808D264-B47E-54FE-AF22-03E68A3AAB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71933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1D905BA-CDB3-D314-FB14-88C6FCFD35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05133F-A991-4F8B-BBDA-5CD637B59EE3}" type="datetime1">
              <a:rPr lang="en-US" smtClean="0"/>
              <a:t>5/22/2023</a:t>
            </a:fld>
            <a:endParaRPr lang="en-US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21482A5-ACF9-DCFB-57DA-B9032DDDEF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4A863CD-4858-0987-6233-199BD878A9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460709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6CE4B3-C51F-97EB-DD73-9289384218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B58D374-96E7-AF55-6E67-A3FFBFAA603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4A78F35-07E9-4350-2B1C-4C7D2D1E65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59D1FE-6BC0-33C9-4374-AB92770889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89718-1F9A-4C1F-93AE-5036A61C958C}" type="datetime1">
              <a:rPr lang="en-US" smtClean="0"/>
              <a:t>5/22/2023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CA304FF-473C-F549-D5A6-68ABA79E5C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C631F9-4F7F-28A5-96B2-4B3CB9BE27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94155205"/>
      </p:ext>
    </p:extLst>
  </p:cSld>
  <p:clrMapOvr>
    <a:masterClrMapping/>
  </p:clrMapOvr>
  <p:hf hdr="0" ft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F58B7C-80C0-D1CE-2D2F-E133A6E4FD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F3230AB-8945-0149-37EE-DC4206F57E1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50AD0D8-CCA5-E978-38FC-77FE07C910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F868AE8-99E4-D3C3-A9CD-12ACC272D4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EC115-7E0C-4614-A58F-812CE94E8367}" type="datetime1">
              <a:rPr lang="en-US" smtClean="0"/>
              <a:t>5/22/2023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858C287-4690-BA6A-075D-9907B12406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EC713E-DA0F-EACC-3B84-FA2F0ABECD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285894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32418FE-5109-19A1-CABD-02081083E4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F4FCE1D-870F-3678-48BE-3A13E292C9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C6BB2F-E65B-4530-92D2-EC329A7FDE3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189718-1F9A-4C1F-93AE-5036A61C958C}" type="datetime1">
              <a:rPr lang="en-US" smtClean="0"/>
              <a:t>5/22/2023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E698B0-7715-7EBE-DF6E-7D41B689AE4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AD78A3-7BDE-EE00-12BF-78968280EA4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059233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71" r:id="rId2"/>
    <p:sldLayoutId id="2147483672" r:id="rId3"/>
    <p:sldLayoutId id="2147483673" r:id="rId4"/>
    <p:sldLayoutId id="2147483674" r:id="rId5"/>
    <p:sldLayoutId id="2147483675" r:id="rId6"/>
    <p:sldLayoutId id="2147483676" r:id="rId7"/>
    <p:sldLayoutId id="2147483677" r:id="rId8"/>
    <p:sldLayoutId id="2147483678" r:id="rId9"/>
    <p:sldLayoutId id="2147483679" r:id="rId10"/>
    <p:sldLayoutId id="2147483680" r:id="rId11"/>
    <p:sldLayoutId id="2147483681" r:id="rId12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4.JPG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8C2F519A-F321-40AC-8054-7ED5F922ECC2}"/>
              </a:ext>
            </a:extLst>
          </p:cNvPr>
          <p:cNvSpPr txBox="1"/>
          <p:nvPr/>
        </p:nvSpPr>
        <p:spPr>
          <a:xfrm>
            <a:off x="2919907" y="5650870"/>
            <a:ext cx="677563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Chromosomes of the offspring plants with green hypocotyls. a: 2n = 17; b: 2n = 34; c: 2n = 33; d: 2n = 32</a:t>
            </a:r>
          </a:p>
        </p:txBody>
      </p:sp>
      <p:grpSp>
        <p:nvGrpSpPr>
          <p:cNvPr id="14" name="Group 13"/>
          <p:cNvGrpSpPr/>
          <p:nvPr/>
        </p:nvGrpSpPr>
        <p:grpSpPr>
          <a:xfrm>
            <a:off x="2882759" y="1217529"/>
            <a:ext cx="6812954" cy="4433341"/>
            <a:chOff x="1141398" y="3398764"/>
            <a:chExt cx="2809256" cy="2583536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025" t="31419" r="7284" b="13536"/>
            <a:stretch/>
          </p:blipFill>
          <p:spPr>
            <a:xfrm>
              <a:off x="1141398" y="3398764"/>
              <a:ext cx="1404593" cy="1291769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631" t="15954" r="5507" b="8927"/>
            <a:stretch/>
          </p:blipFill>
          <p:spPr>
            <a:xfrm>
              <a:off x="1141398" y="4690532"/>
              <a:ext cx="1404593" cy="1291768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426" r="4086" b="17613"/>
            <a:stretch/>
          </p:blipFill>
          <p:spPr>
            <a:xfrm>
              <a:off x="2545991" y="3398764"/>
              <a:ext cx="1404593" cy="1291768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599" t="3246" r="36571" b="25935"/>
            <a:stretch/>
          </p:blipFill>
          <p:spPr>
            <a:xfrm>
              <a:off x="2545991" y="4690532"/>
              <a:ext cx="1404593" cy="1291768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2346574" y="4382755"/>
              <a:ext cx="240941" cy="2152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709713" y="4382755"/>
              <a:ext cx="240941" cy="2152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346574" y="5691439"/>
              <a:ext cx="240941" cy="2152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c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709713" y="5691439"/>
              <a:ext cx="240941" cy="2152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d</a:t>
              </a:r>
            </a:p>
          </p:txBody>
        </p:sp>
      </p:grpSp>
      <p:sp>
        <p:nvSpPr>
          <p:cNvPr id="4" name="Rectangle 3"/>
          <p:cNvSpPr/>
          <p:nvPr/>
        </p:nvSpPr>
        <p:spPr>
          <a:xfrm>
            <a:off x="3859076" y="386533"/>
            <a:ext cx="4125232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2" indent="-914400"/>
            <a:r>
              <a:rPr lang="en-US" sz="3600" dirty="0">
                <a:solidFill>
                  <a:schemeClr val="tx2">
                    <a:lumMod val="50000"/>
                  </a:schemeClr>
                </a:solidFill>
              </a:rPr>
              <a:t>Chromosome counting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7C41C30-9258-ABAC-33CC-B84105464456}"/>
              </a:ext>
            </a:extLst>
          </p:cNvPr>
          <p:cNvSpPr txBox="1"/>
          <p:nvPr/>
        </p:nvSpPr>
        <p:spPr>
          <a:xfrm>
            <a:off x="0" y="-12722"/>
            <a:ext cx="2374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S2</a:t>
            </a:r>
          </a:p>
        </p:txBody>
      </p:sp>
    </p:spTree>
    <p:extLst>
      <p:ext uri="{BB962C8B-B14F-4D97-AF65-F5344CB8AC3E}">
        <p14:creationId xmlns:p14="http://schemas.microsoft.com/office/powerpoint/2010/main" val="8839245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316</TotalTime>
  <Words>42</Words>
  <Application>Microsoft Office PowerPoint</Application>
  <PresentationFormat>Widescreen</PresentationFormat>
  <Paragraphs>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Hongxia - ARS</dc:creator>
  <cp:lastModifiedBy>Chao, Wun - REE-ARS</cp:lastModifiedBy>
  <cp:revision>272</cp:revision>
  <dcterms:created xsi:type="dcterms:W3CDTF">2018-02-23T17:16:05Z</dcterms:created>
  <dcterms:modified xsi:type="dcterms:W3CDTF">2023-05-22T18:39:21Z</dcterms:modified>
</cp:coreProperties>
</file>